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48" d="100"/>
          <a:sy n="48" d="100"/>
        </p:scale>
        <p:origin x="1320" y="5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228600" y="457205"/>
          <a:ext cx="8686800" cy="6248394"/>
        </p:xfrm>
        <a:graphic>
          <a:graphicData uri="http://schemas.openxmlformats.org/drawingml/2006/table">
            <a:tbl>
              <a:tblPr rtl="1"/>
              <a:tblGrid>
                <a:gridCol w="396524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70985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1169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694266">
                <a:tc>
                  <a:txBody>
                    <a:bodyPr/>
                    <a:lstStyle/>
                    <a:p>
                      <a:pPr algn="just" rt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latin typeface="Times New Roman"/>
                          <a:ea typeface="Calibri"/>
                          <a:cs typeface="Arial"/>
                        </a:rPr>
                        <a:t>Reverse primers</a:t>
                      </a:r>
                      <a:endParaRPr lang="en-US" sz="1400" dirty="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latin typeface="Times New Roman"/>
                          <a:ea typeface="Calibri"/>
                          <a:cs typeface="Arial"/>
                        </a:rPr>
                        <a:t>Forward primers</a:t>
                      </a:r>
                      <a:endParaRPr lang="en-US" sz="1400" dirty="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latin typeface="Times New Roman"/>
                          <a:ea typeface="Calibri"/>
                          <a:cs typeface="Arial"/>
                        </a:rPr>
                        <a:t>Gene</a:t>
                      </a:r>
                      <a:endParaRPr lang="en-US" sz="1400" dirty="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694266">
                <a:tc>
                  <a:txBody>
                    <a:bodyPr/>
                    <a:lstStyle/>
                    <a:p>
                      <a:pPr algn="just" rt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>
                          <a:latin typeface="Times New Roman"/>
                          <a:ea typeface="Calibri"/>
                          <a:cs typeface="Arial"/>
                        </a:rPr>
                        <a:t>5-GCCATGGAATTTGCCATGGGTGG-3</a:t>
                      </a:r>
                      <a:endParaRPr lang="en-US" sz="140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latin typeface="Times New Roman"/>
                          <a:ea typeface="Calibri"/>
                          <a:cs typeface="Arial"/>
                        </a:rPr>
                        <a:t>5-TGAAGGTCGGAGTCAACGGATTT-3</a:t>
                      </a:r>
                      <a:endParaRPr lang="en-US" sz="1400" dirty="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>
                          <a:latin typeface="Times New Roman"/>
                          <a:ea typeface="Calibri"/>
                          <a:cs typeface="Arial"/>
                        </a:rPr>
                        <a:t>GAPDH</a:t>
                      </a:r>
                      <a:endParaRPr lang="en-US" sz="140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694266">
                <a:tc>
                  <a:txBody>
                    <a:bodyPr/>
                    <a:lstStyle/>
                    <a:p>
                      <a:pPr algn="just" rt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latin typeface="Times New Roman"/>
                          <a:ea typeface="Calibri"/>
                          <a:cs typeface="Arial"/>
                        </a:rPr>
                        <a:t>5- CATTTGAATCAGGAAGCTGC-3</a:t>
                      </a:r>
                      <a:endParaRPr lang="en-US" sz="1400" dirty="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latin typeface="Times New Roman"/>
                          <a:ea typeface="Calibri"/>
                          <a:cs typeface="Arial"/>
                        </a:rPr>
                        <a:t>5-CCCTTCCTTCGAAATGCAAT-3</a:t>
                      </a:r>
                      <a:endParaRPr lang="en-US" sz="1400" dirty="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>
                          <a:latin typeface="Times New Roman"/>
                          <a:ea typeface="Calibri"/>
                          <a:cs typeface="Arial"/>
                        </a:rPr>
                        <a:t>COX2</a:t>
                      </a:r>
                      <a:endParaRPr lang="en-US" sz="140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694266">
                <a:tc>
                  <a:txBody>
                    <a:bodyPr/>
                    <a:lstStyle/>
                    <a:p>
                      <a:pPr algn="just" rt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>
                          <a:latin typeface="Times New Roman"/>
                          <a:ea typeface="Calibri"/>
                          <a:cs typeface="Arial"/>
                        </a:rPr>
                        <a:t>5-CAGGGGTGGTTATTGCATCT-3</a:t>
                      </a:r>
                      <a:endParaRPr lang="en-US" sz="140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latin typeface="Times New Roman"/>
                          <a:ea typeface="Calibri"/>
                          <a:cs typeface="Arial"/>
                        </a:rPr>
                        <a:t>5-GAGACTTGCCTGGTGAAAAT-3</a:t>
                      </a:r>
                      <a:endParaRPr lang="en-US" sz="1400" dirty="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>
                          <a:latin typeface="Times New Roman"/>
                          <a:ea typeface="Calibri"/>
                          <a:cs typeface="Arial"/>
                        </a:rPr>
                        <a:t>IL-6</a:t>
                      </a:r>
                      <a:endParaRPr lang="en-US" sz="140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694266">
                <a:tc>
                  <a:txBody>
                    <a:bodyPr/>
                    <a:lstStyle/>
                    <a:p>
                      <a:pPr algn="just" rt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>
                          <a:latin typeface="Times New Roman"/>
                          <a:ea typeface="Calibri"/>
                          <a:cs typeface="Arial"/>
                        </a:rPr>
                        <a:t>5-TTTTTTGCTGTGAGTCCCGG-3</a:t>
                      </a:r>
                      <a:endParaRPr lang="en-US" sz="140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latin typeface="Times New Roman"/>
                          <a:ea typeface="Calibri"/>
                          <a:cs typeface="Arial"/>
                        </a:rPr>
                        <a:t>5-GGACAAGCTGAGGAAGATGGC-3</a:t>
                      </a:r>
                      <a:endParaRPr lang="en-US" sz="1400" dirty="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>
                          <a:latin typeface="Times New Roman"/>
                          <a:ea typeface="Calibri"/>
                          <a:cs typeface="Arial"/>
                        </a:rPr>
                        <a:t>IL1-β</a:t>
                      </a:r>
                      <a:endParaRPr lang="en-US" sz="140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694266">
                <a:tc>
                  <a:txBody>
                    <a:bodyPr/>
                    <a:lstStyle/>
                    <a:p>
                      <a:pPr algn="just" rt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>
                          <a:latin typeface="Times New Roman"/>
                          <a:ea typeface="Calibri"/>
                          <a:cs typeface="Arial"/>
                        </a:rPr>
                        <a:t>5-GAAAGGAGAAGAGCCTGAAGTG-3</a:t>
                      </a:r>
                      <a:endParaRPr lang="en-US" sz="140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latin typeface="Times New Roman"/>
                          <a:ea typeface="Calibri"/>
                          <a:cs typeface="Arial"/>
                        </a:rPr>
                        <a:t>5- TGCCCAAGAATAGATGCTGAC-3</a:t>
                      </a:r>
                      <a:endParaRPr lang="en-US" sz="1400" dirty="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>
                          <a:latin typeface="Times New Roman"/>
                          <a:ea typeface="Calibri"/>
                          <a:cs typeface="Arial"/>
                        </a:rPr>
                        <a:t>MMP2</a:t>
                      </a:r>
                      <a:endParaRPr lang="en-US" sz="140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694266">
                <a:tc>
                  <a:txBody>
                    <a:bodyPr/>
                    <a:lstStyle/>
                    <a:p>
                      <a:pPr algn="just" rt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>
                          <a:latin typeface="Times New Roman"/>
                          <a:ea typeface="Calibri"/>
                          <a:cs typeface="Arial"/>
                        </a:rPr>
                        <a:t>5-TTCAGGGCGAGGACCATAGAGG-3</a:t>
                      </a:r>
                      <a:endParaRPr lang="en-US" sz="140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latin typeface="Times New Roman"/>
                          <a:ea typeface="Calibri"/>
                          <a:cs typeface="Arial"/>
                        </a:rPr>
                        <a:t>- CTTCTGCCCGGACCAAGGATAC-3</a:t>
                      </a:r>
                      <a:endParaRPr lang="en-US" sz="1400" dirty="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>
                          <a:latin typeface="Times New Roman"/>
                          <a:ea typeface="Calibri"/>
                          <a:cs typeface="Arial"/>
                        </a:rPr>
                        <a:t>MMP9</a:t>
                      </a:r>
                      <a:endParaRPr lang="en-US" sz="140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694266">
                <a:tc>
                  <a:txBody>
                    <a:bodyPr/>
                    <a:lstStyle/>
                    <a:p>
                      <a:pPr algn="just" rt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>
                          <a:latin typeface="Times New Roman"/>
                          <a:ea typeface="Calibri"/>
                          <a:cs typeface="Arial"/>
                        </a:rPr>
                        <a:t>5- TGTTCCTCTATGGGGTCGTCA-3</a:t>
                      </a:r>
                      <a:endParaRPr lang="en-US" sz="140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rtl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ar-EG" sz="1400" dirty="0">
                          <a:latin typeface="Calibri"/>
                          <a:ea typeface="Calibri"/>
                          <a:cs typeface="Times New Roman"/>
                        </a:rPr>
                        <a:t>5- </a:t>
                      </a:r>
                      <a:r>
                        <a:rPr lang="en-US" sz="1400" b="1" dirty="0">
                          <a:latin typeface="Times New Roman"/>
                          <a:ea typeface="Calibri"/>
                          <a:cs typeface="Arial"/>
                        </a:rPr>
                        <a:t>ACTTGGCCCAGTGGGTTTT-3</a:t>
                      </a:r>
                      <a:endParaRPr lang="en-US" sz="1400" dirty="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>
                          <a:latin typeface="Times New Roman"/>
                          <a:ea typeface="Calibri"/>
                          <a:cs typeface="Arial"/>
                        </a:rPr>
                        <a:t>Survivin</a:t>
                      </a:r>
                      <a:endParaRPr lang="en-US" sz="140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694266">
                <a:tc>
                  <a:txBody>
                    <a:bodyPr/>
                    <a:lstStyle/>
                    <a:p>
                      <a:pPr algn="just" rt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>
                          <a:latin typeface="Times New Roman"/>
                          <a:ea typeface="Calibri"/>
                          <a:cs typeface="Arial"/>
                        </a:rPr>
                        <a:t>5- TGGCTTAGTGGCAGAGTCAG-3</a:t>
                      </a:r>
                      <a:endParaRPr lang="en-US" sz="140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rtl="1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ar-EG" sz="1400" dirty="0">
                          <a:latin typeface="Calibri"/>
                          <a:ea typeface="Calibri"/>
                          <a:cs typeface="Times New Roman"/>
                        </a:rPr>
                        <a:t>5- </a:t>
                      </a:r>
                      <a:r>
                        <a:rPr lang="en-US" sz="1400" b="1" dirty="0">
                          <a:latin typeface="Times New Roman"/>
                          <a:ea typeface="Calibri"/>
                          <a:cs typeface="Arial"/>
                        </a:rPr>
                        <a:t>CAGGAAATCCTCAGCAACAAAA-3</a:t>
                      </a:r>
                      <a:endParaRPr lang="en-US" sz="1400" dirty="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latin typeface="Times New Roman"/>
                          <a:ea typeface="Calibri"/>
                          <a:cs typeface="Arial"/>
                        </a:rPr>
                        <a:t>Ki-67</a:t>
                      </a:r>
                      <a:endParaRPr lang="en-US" sz="1400" dirty="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0" y="0"/>
            <a:ext cx="4949945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Table 1: Primer sequences for real time RT-PCR</a:t>
            </a:r>
            <a:endParaRPr kumimoji="0" lang="en-US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45</Words>
  <Application>Microsoft Office PowerPoint</Application>
  <PresentationFormat>On-screen Show (4:3)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ci</dc:creator>
  <cp:lastModifiedBy>nub</cp:lastModifiedBy>
  <cp:revision>5</cp:revision>
  <dcterms:created xsi:type="dcterms:W3CDTF">2006-08-16T00:00:00Z</dcterms:created>
  <dcterms:modified xsi:type="dcterms:W3CDTF">2020-01-25T07:34:10Z</dcterms:modified>
</cp:coreProperties>
</file>